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A92D34-AED7-4284-805D-4389082074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BCB92-1470-4FE1-9C28-942C304F61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639405-5D19-4DD6-BEF1-3DAA0D9480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571A3E-3BE7-44EA-B7DE-94EB874574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10B219-0D30-499B-903A-B757419D4F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C1BD1F-5D0D-4298-9370-FBFA11E9C2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ADECC6-D9E6-4F90-9CB4-B00CFBAE5B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A7EAA-89E2-4A3D-B969-3462D3BBBF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3D73EB-E055-4E2D-A875-D10AF836CA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76928-9F47-423C-B92B-399FAA1934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D3FE5F-DE8A-4BBB-B006-32D907DB5A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3BBC68-095D-4562-9275-4325AFD33D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4E6729-4D07-4A42-88CD-5F2ABD0533A2}" type="slidenum">
              <a:rPr b="0" lang="ja-JP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736640" y="4956120"/>
            <a:ext cx="4595760" cy="28893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962000" y="6602400"/>
            <a:ext cx="4137120" cy="1093680"/>
          </a:xfrm>
          <a:custGeom>
            <a:avLst/>
            <a:gdLst/>
            <a:ahLst/>
            <a:rect l="l" t="t" r="r" b="b"/>
            <a:pathLst>
              <a:path w="2606" h="689">
                <a:moveTo>
                  <a:pt x="0" y="681"/>
                </a:moveTo>
                <a:lnTo>
                  <a:pt x="289" y="689"/>
                </a:lnTo>
                <a:lnTo>
                  <a:pt x="578" y="0"/>
                </a:lnTo>
                <a:lnTo>
                  <a:pt x="868" y="100"/>
                </a:lnTo>
                <a:lnTo>
                  <a:pt x="1157" y="357"/>
                </a:lnTo>
                <a:lnTo>
                  <a:pt x="1448" y="361"/>
                </a:lnTo>
                <a:lnTo>
                  <a:pt x="1738" y="375"/>
                </a:lnTo>
                <a:lnTo>
                  <a:pt x="2027" y="434"/>
                </a:lnTo>
                <a:lnTo>
                  <a:pt x="2316" y="420"/>
                </a:lnTo>
                <a:lnTo>
                  <a:pt x="2606" y="441"/>
                </a:lnTo>
              </a:path>
            </a:pathLst>
          </a:custGeom>
          <a:noFill/>
          <a:ln w="381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962000" y="5489640"/>
            <a:ext cx="4137120" cy="2136600"/>
          </a:xfrm>
          <a:custGeom>
            <a:avLst/>
            <a:gdLst/>
            <a:ahLst/>
            <a:rect l="l" t="t" r="r" b="b"/>
            <a:pathLst>
              <a:path w="2606" h="1346">
                <a:moveTo>
                  <a:pt x="0" y="1346"/>
                </a:moveTo>
                <a:lnTo>
                  <a:pt x="289" y="1132"/>
                </a:lnTo>
                <a:lnTo>
                  <a:pt x="578" y="0"/>
                </a:lnTo>
                <a:lnTo>
                  <a:pt x="868" y="617"/>
                </a:lnTo>
                <a:lnTo>
                  <a:pt x="1157" y="848"/>
                </a:lnTo>
                <a:lnTo>
                  <a:pt x="1448" y="993"/>
                </a:lnTo>
                <a:lnTo>
                  <a:pt x="1738" y="1023"/>
                </a:lnTo>
                <a:lnTo>
                  <a:pt x="2027" y="1049"/>
                </a:lnTo>
                <a:lnTo>
                  <a:pt x="2316" y="1122"/>
                </a:lnTo>
                <a:lnTo>
                  <a:pt x="2606" y="1240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962000" y="5267160"/>
            <a:ext cx="4137120" cy="2337120"/>
          </a:xfrm>
          <a:custGeom>
            <a:avLst/>
            <a:gdLst/>
            <a:ahLst/>
            <a:rect l="l" t="t" r="r" b="b"/>
            <a:pathLst>
              <a:path w="2606" h="1472">
                <a:moveTo>
                  <a:pt x="0" y="1472"/>
                </a:moveTo>
                <a:lnTo>
                  <a:pt x="289" y="1053"/>
                </a:lnTo>
                <a:lnTo>
                  <a:pt x="578" y="0"/>
                </a:lnTo>
                <a:lnTo>
                  <a:pt x="868" y="481"/>
                </a:lnTo>
                <a:lnTo>
                  <a:pt x="1157" y="675"/>
                </a:lnTo>
                <a:lnTo>
                  <a:pt x="1448" y="1096"/>
                </a:lnTo>
                <a:lnTo>
                  <a:pt x="1738" y="1174"/>
                </a:lnTo>
                <a:lnTo>
                  <a:pt x="2027" y="1152"/>
                </a:lnTo>
                <a:lnTo>
                  <a:pt x="2316" y="1262"/>
                </a:lnTo>
                <a:lnTo>
                  <a:pt x="2606" y="1238"/>
                </a:lnTo>
              </a:path>
            </a:pathLst>
          </a:custGeom>
          <a:noFill/>
          <a:ln w="17640">
            <a:solidFill>
              <a:srgbClr val="000000"/>
            </a:solidFill>
            <a:prstDash val="lgDash"/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506240" y="770724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506240" y="722628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506240" y="674532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506240" y="626436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506240" y="578160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506240" y="530064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506240" y="481968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H="1">
            <a:off x="1746000" y="5442120"/>
            <a:ext cx="75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H="1">
            <a:off x="1746000" y="5924520"/>
            <a:ext cx="75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>
            <a:off x="1746000" y="6407280"/>
            <a:ext cx="75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H="1">
            <a:off x="1746000" y="6889680"/>
            <a:ext cx="75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H="1">
            <a:off x="1746000" y="7372440"/>
            <a:ext cx="75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"/>
          <p:cNvGrpSpPr/>
          <p:nvPr/>
        </p:nvGrpSpPr>
        <p:grpSpPr>
          <a:xfrm>
            <a:off x="1803240" y="7759800"/>
            <a:ext cx="4518000" cy="724680"/>
            <a:chOff x="1803240" y="7759800"/>
            <a:chExt cx="4518000" cy="724680"/>
          </a:xfrm>
        </p:grpSpPr>
        <p:sp>
          <p:nvSpPr>
            <p:cNvPr id="58" name=""/>
            <p:cNvSpPr/>
            <p:nvPr/>
          </p:nvSpPr>
          <p:spPr>
            <a:xfrm>
              <a:off x="2438280" y="775980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889360" y="775980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340080" y="775980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790800" y="775980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241880" y="775980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699080" y="775980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149800" y="775980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803240" y="7854840"/>
              <a:ext cx="184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286000" y="785484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747880" y="785484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183120" y="785484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649680" y="785484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017600" y="7854840"/>
              <a:ext cx="40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476600" y="7854840"/>
              <a:ext cx="40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4938480" y="7854840"/>
              <a:ext cx="40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4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408280" y="7854840"/>
              <a:ext cx="40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7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884560" y="7854840"/>
              <a:ext cx="40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9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444760" y="8147160"/>
              <a:ext cx="3004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Time Post PMA Treatment (h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6319800" y="7819920"/>
              <a:ext cx="1440" cy="20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949400" y="776592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607000" y="775980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6076800" y="7765920"/>
              <a:ext cx="0" cy="76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0" name=""/>
          <p:cNvGrpSpPr/>
          <p:nvPr/>
        </p:nvGrpSpPr>
        <p:grpSpPr>
          <a:xfrm>
            <a:off x="4343400" y="5067360"/>
            <a:ext cx="2057400" cy="761760"/>
            <a:chOff x="4343400" y="5067360"/>
            <a:chExt cx="2057400" cy="761760"/>
          </a:xfrm>
        </p:grpSpPr>
        <p:sp>
          <p:nvSpPr>
            <p:cNvPr id="81" name=""/>
            <p:cNvSpPr/>
            <p:nvPr/>
          </p:nvSpPr>
          <p:spPr>
            <a:xfrm>
              <a:off x="4343400" y="5067360"/>
              <a:ext cx="1905120" cy="7617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952880" y="5143320"/>
              <a:ext cx="1447920" cy="64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ample 1 (RIKEN1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ample 2 (RIKEN3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ample 3 (RIKEN6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495680" y="5245200"/>
              <a:ext cx="4572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495680" y="544824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495680" y="566424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"/>
          <p:cNvSpPr/>
          <p:nvPr/>
        </p:nvSpPr>
        <p:spPr>
          <a:xfrm rot="16200000">
            <a:off x="-121320" y="6151680"/>
            <a:ext cx="2586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Arial"/>
              </a:rPr>
              <a:t>Fluorecence Units (x 10</a:t>
            </a:r>
            <a:r>
              <a:rPr b="1" lang="ja-JP" sz="16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1" lang="ja-JP" sz="16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07800" y="4343400"/>
            <a:ext cx="73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AB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754280" y="752400"/>
            <a:ext cx="4583160" cy="28782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979640" y="2058840"/>
            <a:ext cx="4124160" cy="1371600"/>
          </a:xfrm>
          <a:custGeom>
            <a:avLst/>
            <a:gdLst/>
            <a:ahLst/>
            <a:rect l="l" t="t" r="r" b="b"/>
            <a:pathLst>
              <a:path w="2598" h="864">
                <a:moveTo>
                  <a:pt x="0" y="628"/>
                </a:moveTo>
                <a:lnTo>
                  <a:pt x="288" y="604"/>
                </a:lnTo>
                <a:lnTo>
                  <a:pt x="577" y="0"/>
                </a:lnTo>
                <a:lnTo>
                  <a:pt x="865" y="115"/>
                </a:lnTo>
                <a:lnTo>
                  <a:pt x="1154" y="408"/>
                </a:lnTo>
                <a:lnTo>
                  <a:pt x="1444" y="575"/>
                </a:lnTo>
                <a:lnTo>
                  <a:pt x="1732" y="776"/>
                </a:lnTo>
                <a:lnTo>
                  <a:pt x="2021" y="707"/>
                </a:lnTo>
                <a:lnTo>
                  <a:pt x="2309" y="733"/>
                </a:lnTo>
                <a:lnTo>
                  <a:pt x="2598" y="864"/>
                </a:lnTo>
              </a:path>
            </a:pathLst>
          </a:custGeom>
          <a:noFill/>
          <a:ln w="381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979640" y="1517760"/>
            <a:ext cx="4124160" cy="1822320"/>
          </a:xfrm>
          <a:custGeom>
            <a:avLst/>
            <a:gdLst/>
            <a:ahLst/>
            <a:rect l="l" t="t" r="r" b="b"/>
            <a:pathLst>
              <a:path w="2598" h="1148">
                <a:moveTo>
                  <a:pt x="0" y="1106"/>
                </a:moveTo>
                <a:lnTo>
                  <a:pt x="288" y="1036"/>
                </a:lnTo>
                <a:lnTo>
                  <a:pt x="577" y="0"/>
                </a:lnTo>
                <a:lnTo>
                  <a:pt x="865" y="731"/>
                </a:lnTo>
                <a:lnTo>
                  <a:pt x="1154" y="857"/>
                </a:lnTo>
                <a:lnTo>
                  <a:pt x="1444" y="1110"/>
                </a:lnTo>
                <a:lnTo>
                  <a:pt x="1732" y="1148"/>
                </a:lnTo>
                <a:lnTo>
                  <a:pt x="2021" y="1138"/>
                </a:lnTo>
                <a:lnTo>
                  <a:pt x="2309" y="1133"/>
                </a:lnTo>
                <a:lnTo>
                  <a:pt x="2598" y="1099"/>
                </a:lnTo>
              </a:path>
            </a:pathLst>
          </a:custGeom>
          <a:noFill/>
          <a:ln w="176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979640" y="1139760"/>
            <a:ext cx="4124160" cy="2190960"/>
          </a:xfrm>
          <a:custGeom>
            <a:avLst/>
            <a:gdLst/>
            <a:ahLst/>
            <a:rect l="l" t="t" r="r" b="b"/>
            <a:pathLst>
              <a:path w="2598" h="1380">
                <a:moveTo>
                  <a:pt x="0" y="1190"/>
                </a:moveTo>
                <a:lnTo>
                  <a:pt x="288" y="1077"/>
                </a:lnTo>
                <a:lnTo>
                  <a:pt x="577" y="0"/>
                </a:lnTo>
                <a:lnTo>
                  <a:pt x="865" y="848"/>
                </a:lnTo>
                <a:lnTo>
                  <a:pt x="1154" y="1154"/>
                </a:lnTo>
                <a:lnTo>
                  <a:pt x="1444" y="1061"/>
                </a:lnTo>
                <a:lnTo>
                  <a:pt x="1732" y="1271"/>
                </a:lnTo>
                <a:lnTo>
                  <a:pt x="2021" y="1286"/>
                </a:lnTo>
                <a:lnTo>
                  <a:pt x="2309" y="1304"/>
                </a:lnTo>
                <a:lnTo>
                  <a:pt x="2598" y="1380"/>
                </a:lnTo>
              </a:path>
            </a:pathLst>
          </a:custGeom>
          <a:noFill/>
          <a:ln w="17640">
            <a:solidFill>
              <a:srgbClr val="000000"/>
            </a:solidFill>
            <a:prstDash val="lgDash"/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1518840" y="349560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518840" y="291924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518840" y="234324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518840" y="176832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518840" y="119232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518840" y="615960"/>
            <a:ext cx="113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H="1">
            <a:off x="1752480" y="1333440"/>
            <a:ext cx="76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flipH="1">
            <a:off x="1752480" y="1911240"/>
            <a:ext cx="76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H="1">
            <a:off x="1752480" y="2482920"/>
            <a:ext cx="76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flipH="1">
            <a:off x="1752480" y="3060720"/>
            <a:ext cx="76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2" name=""/>
          <p:cNvGrpSpPr/>
          <p:nvPr/>
        </p:nvGrpSpPr>
        <p:grpSpPr>
          <a:xfrm>
            <a:off x="1809720" y="3543480"/>
            <a:ext cx="4518000" cy="724320"/>
            <a:chOff x="1809720" y="3543480"/>
            <a:chExt cx="4518000" cy="724320"/>
          </a:xfrm>
        </p:grpSpPr>
        <p:sp>
          <p:nvSpPr>
            <p:cNvPr id="103" name=""/>
            <p:cNvSpPr/>
            <p:nvPr/>
          </p:nvSpPr>
          <p:spPr>
            <a:xfrm>
              <a:off x="2444760" y="3543480"/>
              <a:ext cx="0" cy="7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895840" y="3543480"/>
              <a:ext cx="0" cy="7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346560" y="3543480"/>
              <a:ext cx="0" cy="7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797280" y="3543480"/>
              <a:ext cx="0" cy="7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248360" y="3543480"/>
              <a:ext cx="0" cy="7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705560" y="3543480"/>
              <a:ext cx="0" cy="7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156280" y="3543480"/>
              <a:ext cx="0" cy="7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1809720" y="3638160"/>
              <a:ext cx="184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292480" y="363816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754360" y="363816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189600" y="363816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656160" y="363816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024080" y="3638160"/>
              <a:ext cx="40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483080" y="3638160"/>
              <a:ext cx="40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944960" y="3638160"/>
              <a:ext cx="40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4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5414760" y="3638160"/>
              <a:ext cx="40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7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5891040" y="3638160"/>
              <a:ext cx="40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9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2451240" y="3930480"/>
              <a:ext cx="3004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Time Post PMA Treatment (h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V="1">
              <a:off x="6326280" y="3602880"/>
              <a:ext cx="144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955880" y="3549240"/>
              <a:ext cx="0" cy="7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613480" y="3543480"/>
              <a:ext cx="0" cy="7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6083280" y="3549240"/>
              <a:ext cx="0" cy="75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5" name=""/>
          <p:cNvSpPr/>
          <p:nvPr/>
        </p:nvSpPr>
        <p:spPr>
          <a:xfrm rot="16200000">
            <a:off x="-133920" y="1968840"/>
            <a:ext cx="2586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Arial"/>
              </a:rPr>
              <a:t>Fluorecence Units (x 10</a:t>
            </a:r>
            <a:r>
              <a:rPr b="1" lang="ja-JP" sz="16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1" lang="ja-JP" sz="16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6" name=""/>
          <p:cNvGrpSpPr/>
          <p:nvPr/>
        </p:nvGrpSpPr>
        <p:grpSpPr>
          <a:xfrm>
            <a:off x="4343400" y="863640"/>
            <a:ext cx="2057400" cy="761760"/>
            <a:chOff x="4343400" y="863640"/>
            <a:chExt cx="2057400" cy="761760"/>
          </a:xfrm>
        </p:grpSpPr>
        <p:sp>
          <p:nvSpPr>
            <p:cNvPr id="127" name=""/>
            <p:cNvSpPr/>
            <p:nvPr/>
          </p:nvSpPr>
          <p:spPr>
            <a:xfrm>
              <a:off x="4343400" y="863640"/>
              <a:ext cx="1905120" cy="7617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952880" y="939600"/>
              <a:ext cx="1447920" cy="64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ample 1 (RIKEN1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ample 2 (RIKEN3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Sample 3 (RIKEN6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4495680" y="1041480"/>
              <a:ext cx="4572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495680" y="124452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495680" y="146052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2" name=""/>
          <p:cNvSpPr/>
          <p:nvPr/>
        </p:nvSpPr>
        <p:spPr>
          <a:xfrm>
            <a:off x="307800" y="228600"/>
            <a:ext cx="73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AB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267080" y="8686800"/>
            <a:ext cx="251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800" spc="-1" strike="noStrike">
                <a:solidFill>
                  <a:srgbClr val="000000"/>
                </a:solidFill>
                <a:latin typeface="Arial"/>
              </a:rPr>
              <a:t>Additional data file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13T05:15:50Z</dcterms:created>
  <dc:creator>Kubosaki</dc:creator>
  <dc:description/>
  <dc:language>en-US</dc:language>
  <cp:lastModifiedBy>Kubosaki</cp:lastModifiedBy>
  <dcterms:modified xsi:type="dcterms:W3CDTF">2009-04-03T03:34:46Z</dcterms:modified>
  <cp:revision>9</cp:revision>
  <dc:subject/>
  <dc:title>PowerPoint プレゼンテーション</dc:title>
</cp:coreProperties>
</file>